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65F84C-F458-48DA-B848-F225B63DA7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5A1EA7-97CC-46B9-8260-2761811A71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E32E63-8ED5-48BE-AFEC-C14D1138A97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A62CCA-F385-4A3F-AE22-0CB82A2213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02900C-A7F9-4D1E-9346-F5AC6178C9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38F515-18F3-49D6-91FC-0895D2B863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ADA2A-4330-4165-9272-43643F9F20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2B232-1BD5-4990-9D38-6FF612831E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72FFA-5609-4FE8-97AB-7635D11635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D87E5-7257-4F66-AE91-0137B9E146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D20326-0DB3-4176-BC96-3F37388290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398BB9-EFC6-49C2-9745-DEEFE258D1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066FB2-E7D9-4A7E-B2DE-DAF12AAC7855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2033640" y="522360"/>
            <a:ext cx="3330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Supplementary Dat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2"/>
          <p:cNvSpPr/>
          <p:nvPr/>
        </p:nvSpPr>
        <p:spPr>
          <a:xfrm>
            <a:off x="458640" y="110664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.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图表 3" descr=""/>
          <p:cNvPicPr/>
          <p:nvPr/>
        </p:nvPicPr>
        <p:blipFill>
          <a:blip r:embed="rId1"/>
          <a:stretch/>
        </p:blipFill>
        <p:spPr>
          <a:xfrm>
            <a:off x="1609560" y="1981080"/>
            <a:ext cx="3492720" cy="1828800"/>
          </a:xfrm>
          <a:prstGeom prst="rect">
            <a:avLst/>
          </a:prstGeom>
          <a:ln w="0">
            <a:noFill/>
          </a:ln>
        </p:spPr>
      </p:pic>
      <p:sp>
        <p:nvSpPr>
          <p:cNvPr id="44" name="矩形 4"/>
          <p:cNvSpPr/>
          <p:nvPr/>
        </p:nvSpPr>
        <p:spPr>
          <a:xfrm>
            <a:off x="201600" y="3986280"/>
            <a:ext cx="63770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ree lung cancer cells were resistant to necroptotic stimuli. The indicated cancer cells were treated with DMSO or T/S/Z for 48 hours. Cell viability was determined by measuring ATP levels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1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24T08:23:54Z</dcterms:created>
  <dc:creator>lj</dc:creator>
  <dc:description/>
  <dc:language>en-US</dc:language>
  <cp:lastModifiedBy>vidya.p</cp:lastModifiedBy>
  <cp:lastPrinted>2016-03-10T05:57:39Z</cp:lastPrinted>
  <dcterms:modified xsi:type="dcterms:W3CDTF">2017-09-28T04:23:52Z</dcterms:modified>
  <cp:revision>423</cp:revision>
  <dc:subject/>
  <dc:title>幻灯片 1</dc:title>
</cp:coreProperties>
</file>